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72" y="78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hrsfai:Documents:Publications:Circadian%20defence%20paper:June%202015:jaz6_expression_windra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4.1912862764646598E-2"/>
          <c:y val="1.8140589569161002E-2"/>
          <c:w val="0.95808713723535299"/>
          <c:h val="0.94203081757637397"/>
        </c:manualLayout>
      </c:layout>
      <c:lineChart>
        <c:grouping val="standard"/>
        <c:varyColors val="0"/>
        <c:ser>
          <c:idx val="0"/>
          <c:order val="0"/>
          <c:tx>
            <c:v>mock</c:v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B$8:$Y$8</c:f>
                <c:numCache>
                  <c:formatCode>General</c:formatCode>
                  <c:ptCount val="24"/>
                  <c:pt idx="0">
                    <c:v>0.428846013327085</c:v>
                  </c:pt>
                  <c:pt idx="1">
                    <c:v>0.38112271855727903</c:v>
                  </c:pt>
                  <c:pt idx="2">
                    <c:v>0.13548415174616801</c:v>
                  </c:pt>
                  <c:pt idx="3">
                    <c:v>0.126268247090283</c:v>
                  </c:pt>
                  <c:pt idx="4">
                    <c:v>0.45120731006869602</c:v>
                  </c:pt>
                  <c:pt idx="5">
                    <c:v>0.12937636735354499</c:v>
                  </c:pt>
                  <c:pt idx="6">
                    <c:v>0.18447763120272101</c:v>
                  </c:pt>
                  <c:pt idx="7">
                    <c:v>0.17874472189055601</c:v>
                  </c:pt>
                  <c:pt idx="8">
                    <c:v>0.257766633532659</c:v>
                  </c:pt>
                  <c:pt idx="9">
                    <c:v>0.212941377751692</c:v>
                  </c:pt>
                  <c:pt idx="10">
                    <c:v>0.32396414672322299</c:v>
                  </c:pt>
                  <c:pt idx="11">
                    <c:v>0.241650374579441</c:v>
                  </c:pt>
                  <c:pt idx="12">
                    <c:v>0.16416746097224</c:v>
                  </c:pt>
                  <c:pt idx="13">
                    <c:v>0.14603093941425799</c:v>
                  </c:pt>
                  <c:pt idx="14">
                    <c:v>0.26988838772464002</c:v>
                  </c:pt>
                  <c:pt idx="15">
                    <c:v>9.6051824817935394E-2</c:v>
                  </c:pt>
                  <c:pt idx="16">
                    <c:v>0.33702365542810198</c:v>
                  </c:pt>
                  <c:pt idx="17">
                    <c:v>0.36134303688588498</c:v>
                  </c:pt>
                  <c:pt idx="18">
                    <c:v>2.7368093761637801E-2</c:v>
                  </c:pt>
                  <c:pt idx="19">
                    <c:v>0.336855529164026</c:v>
                  </c:pt>
                  <c:pt idx="20">
                    <c:v>0.290714448654812</c:v>
                  </c:pt>
                  <c:pt idx="21">
                    <c:v>0.21095499848160201</c:v>
                  </c:pt>
                  <c:pt idx="22">
                    <c:v>5.4103818847752996E-3</c:v>
                  </c:pt>
                  <c:pt idx="23">
                    <c:v>4.7024623079957001E-2</c:v>
                  </c:pt>
                </c:numCache>
              </c:numRef>
            </c:plus>
            <c:minus>
              <c:numRef>
                <c:f>Sheet1!$B$8:$Y$8</c:f>
                <c:numCache>
                  <c:formatCode>General</c:formatCode>
                  <c:ptCount val="24"/>
                  <c:pt idx="0">
                    <c:v>0.428846013327085</c:v>
                  </c:pt>
                  <c:pt idx="1">
                    <c:v>0.38112271855727903</c:v>
                  </c:pt>
                  <c:pt idx="2">
                    <c:v>0.13548415174616801</c:v>
                  </c:pt>
                  <c:pt idx="3">
                    <c:v>0.126268247090283</c:v>
                  </c:pt>
                  <c:pt idx="4">
                    <c:v>0.45120731006869602</c:v>
                  </c:pt>
                  <c:pt idx="5">
                    <c:v>0.12937636735354499</c:v>
                  </c:pt>
                  <c:pt idx="6">
                    <c:v>0.18447763120272101</c:v>
                  </c:pt>
                  <c:pt idx="7">
                    <c:v>0.17874472189055601</c:v>
                  </c:pt>
                  <c:pt idx="8">
                    <c:v>0.257766633532659</c:v>
                  </c:pt>
                  <c:pt idx="9">
                    <c:v>0.212941377751692</c:v>
                  </c:pt>
                  <c:pt idx="10">
                    <c:v>0.32396414672322299</c:v>
                  </c:pt>
                  <c:pt idx="11">
                    <c:v>0.241650374579441</c:v>
                  </c:pt>
                  <c:pt idx="12">
                    <c:v>0.16416746097224</c:v>
                  </c:pt>
                  <c:pt idx="13">
                    <c:v>0.14603093941425799</c:v>
                  </c:pt>
                  <c:pt idx="14">
                    <c:v>0.26988838772464002</c:v>
                  </c:pt>
                  <c:pt idx="15">
                    <c:v>9.6051824817935394E-2</c:v>
                  </c:pt>
                  <c:pt idx="16">
                    <c:v>0.33702365542810198</c:v>
                  </c:pt>
                  <c:pt idx="17">
                    <c:v>0.36134303688588498</c:v>
                  </c:pt>
                  <c:pt idx="18">
                    <c:v>2.7368093761637801E-2</c:v>
                  </c:pt>
                  <c:pt idx="19">
                    <c:v>0.336855529164026</c:v>
                  </c:pt>
                  <c:pt idx="20">
                    <c:v>0.290714448654812</c:v>
                  </c:pt>
                  <c:pt idx="21">
                    <c:v>0.21095499848160201</c:v>
                  </c:pt>
                  <c:pt idx="22">
                    <c:v>5.4103818847752996E-3</c:v>
                  </c:pt>
                  <c:pt idx="23">
                    <c:v>4.7024623079957001E-2</c:v>
                  </c:pt>
                </c:numCache>
              </c:numRef>
            </c:minus>
          </c:errBars>
          <c:val>
            <c:numRef>
              <c:f>Sheet1!$B$6:$Y$6</c:f>
              <c:numCache>
                <c:formatCode>General</c:formatCode>
                <c:ptCount val="24"/>
                <c:pt idx="0">
                  <c:v>11.06552512606696</c:v>
                </c:pt>
                <c:pt idx="1">
                  <c:v>10.859952408004251</c:v>
                </c:pt>
                <c:pt idx="2">
                  <c:v>11.02973220761023</c:v>
                </c:pt>
                <c:pt idx="3">
                  <c:v>10.36808736293637</c:v>
                </c:pt>
                <c:pt idx="4">
                  <c:v>10.8745562205334</c:v>
                </c:pt>
                <c:pt idx="5">
                  <c:v>11.159701746126229</c:v>
                </c:pt>
                <c:pt idx="6">
                  <c:v>10.99943605872885</c:v>
                </c:pt>
                <c:pt idx="7">
                  <c:v>11.469881466135719</c:v>
                </c:pt>
                <c:pt idx="8">
                  <c:v>11.467842046132599</c:v>
                </c:pt>
                <c:pt idx="9">
                  <c:v>11.632180779145701</c:v>
                </c:pt>
                <c:pt idx="10">
                  <c:v>11.04857724895983</c:v>
                </c:pt>
                <c:pt idx="11">
                  <c:v>11.073032519403551</c:v>
                </c:pt>
                <c:pt idx="12">
                  <c:v>10.5558860079304</c:v>
                </c:pt>
                <c:pt idx="13">
                  <c:v>11.245787522206999</c:v>
                </c:pt>
                <c:pt idx="14">
                  <c:v>10.617816686777999</c:v>
                </c:pt>
                <c:pt idx="15">
                  <c:v>10.629512876240231</c:v>
                </c:pt>
                <c:pt idx="16">
                  <c:v>10.399943619581361</c:v>
                </c:pt>
                <c:pt idx="17">
                  <c:v>10.964758361106981</c:v>
                </c:pt>
                <c:pt idx="18">
                  <c:v>11.15963541691533</c:v>
                </c:pt>
                <c:pt idx="19">
                  <c:v>11.031637635309099</c:v>
                </c:pt>
                <c:pt idx="20">
                  <c:v>11.338723994938119</c:v>
                </c:pt>
                <c:pt idx="21">
                  <c:v>11.34270627188765</c:v>
                </c:pt>
                <c:pt idx="22">
                  <c:v>10.878125324638351</c:v>
                </c:pt>
                <c:pt idx="23">
                  <c:v>11.096530593950471</c:v>
                </c:pt>
              </c:numCache>
            </c:numRef>
          </c:val>
          <c:smooth val="0"/>
        </c:ser>
        <c:ser>
          <c:idx val="1"/>
          <c:order val="1"/>
          <c:tx>
            <c:v>infected</c:v>
          </c:tx>
          <c:spPr>
            <a:ln w="19050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1!$Z$8:$AW$8</c:f>
                <c:numCache>
                  <c:formatCode>General</c:formatCode>
                  <c:ptCount val="24"/>
                  <c:pt idx="0">
                    <c:v>0.17857565051003799</c:v>
                  </c:pt>
                  <c:pt idx="1">
                    <c:v>0.331820357405955</c:v>
                  </c:pt>
                  <c:pt idx="2">
                    <c:v>0.142157666402106</c:v>
                  </c:pt>
                  <c:pt idx="3">
                    <c:v>0.12958567807312599</c:v>
                  </c:pt>
                  <c:pt idx="4">
                    <c:v>0.12561834809529701</c:v>
                  </c:pt>
                  <c:pt idx="5">
                    <c:v>0.33298060145459302</c:v>
                  </c:pt>
                  <c:pt idx="6">
                    <c:v>7.9178307365904102E-2</c:v>
                  </c:pt>
                  <c:pt idx="7">
                    <c:v>0.18222588135427001</c:v>
                  </c:pt>
                  <c:pt idx="8">
                    <c:v>0.40407428464758699</c:v>
                  </c:pt>
                  <c:pt idx="9">
                    <c:v>0.23354452591993599</c:v>
                  </c:pt>
                  <c:pt idx="10">
                    <c:v>0.53792541798801297</c:v>
                  </c:pt>
                  <c:pt idx="11">
                    <c:v>0.62761615445750596</c:v>
                  </c:pt>
                  <c:pt idx="12">
                    <c:v>0.21877105563676399</c:v>
                  </c:pt>
                  <c:pt idx="13">
                    <c:v>0.18817467644521199</c:v>
                  </c:pt>
                  <c:pt idx="14">
                    <c:v>0.178927177413295</c:v>
                  </c:pt>
                  <c:pt idx="15">
                    <c:v>0.27202649509218801</c:v>
                  </c:pt>
                  <c:pt idx="16">
                    <c:v>0.16984509622431701</c:v>
                  </c:pt>
                  <c:pt idx="17">
                    <c:v>0.320866280252812</c:v>
                  </c:pt>
                  <c:pt idx="18">
                    <c:v>0.32003173884158098</c:v>
                  </c:pt>
                  <c:pt idx="19">
                    <c:v>0.11729699132969899</c:v>
                  </c:pt>
                  <c:pt idx="20">
                    <c:v>0.25976371826109301</c:v>
                  </c:pt>
                  <c:pt idx="21">
                    <c:v>9.3148192894740495E-2</c:v>
                  </c:pt>
                  <c:pt idx="22">
                    <c:v>0.239382483601114</c:v>
                  </c:pt>
                  <c:pt idx="23">
                    <c:v>0.30959167920267999</c:v>
                  </c:pt>
                </c:numCache>
              </c:numRef>
            </c:plus>
            <c:minus>
              <c:numRef>
                <c:f>Sheet1!$Z$8:$AW$8</c:f>
                <c:numCache>
                  <c:formatCode>General</c:formatCode>
                  <c:ptCount val="24"/>
                  <c:pt idx="0">
                    <c:v>0.17857565051003799</c:v>
                  </c:pt>
                  <c:pt idx="1">
                    <c:v>0.331820357405955</c:v>
                  </c:pt>
                  <c:pt idx="2">
                    <c:v>0.142157666402106</c:v>
                  </c:pt>
                  <c:pt idx="3">
                    <c:v>0.12958567807312599</c:v>
                  </c:pt>
                  <c:pt idx="4">
                    <c:v>0.12561834809529701</c:v>
                  </c:pt>
                  <c:pt idx="5">
                    <c:v>0.33298060145459302</c:v>
                  </c:pt>
                  <c:pt idx="6">
                    <c:v>7.9178307365904102E-2</c:v>
                  </c:pt>
                  <c:pt idx="7">
                    <c:v>0.18222588135427001</c:v>
                  </c:pt>
                  <c:pt idx="8">
                    <c:v>0.40407428464758699</c:v>
                  </c:pt>
                  <c:pt idx="9">
                    <c:v>0.23354452591993599</c:v>
                  </c:pt>
                  <c:pt idx="10">
                    <c:v>0.53792541798801297</c:v>
                  </c:pt>
                  <c:pt idx="11">
                    <c:v>0.62761615445750596</c:v>
                  </c:pt>
                  <c:pt idx="12">
                    <c:v>0.21877105563676399</c:v>
                  </c:pt>
                  <c:pt idx="13">
                    <c:v>0.18817467644521199</c:v>
                  </c:pt>
                  <c:pt idx="14">
                    <c:v>0.178927177413295</c:v>
                  </c:pt>
                  <c:pt idx="15">
                    <c:v>0.27202649509218801</c:v>
                  </c:pt>
                  <c:pt idx="16">
                    <c:v>0.16984509622431701</c:v>
                  </c:pt>
                  <c:pt idx="17">
                    <c:v>0.320866280252812</c:v>
                  </c:pt>
                  <c:pt idx="18">
                    <c:v>0.32003173884158098</c:v>
                  </c:pt>
                  <c:pt idx="19">
                    <c:v>0.11729699132969899</c:v>
                  </c:pt>
                  <c:pt idx="20">
                    <c:v>0.25976371826109301</c:v>
                  </c:pt>
                  <c:pt idx="21">
                    <c:v>9.3148192894740495E-2</c:v>
                  </c:pt>
                  <c:pt idx="22">
                    <c:v>0.239382483601114</c:v>
                  </c:pt>
                  <c:pt idx="23">
                    <c:v>0.30959167920267999</c:v>
                  </c:pt>
                </c:numCache>
              </c:numRef>
            </c:minus>
          </c:errBars>
          <c:val>
            <c:numRef>
              <c:f>Sheet1!$Z$6:$AW$6</c:f>
              <c:numCache>
                <c:formatCode>General</c:formatCode>
                <c:ptCount val="24"/>
                <c:pt idx="0">
                  <c:v>11.21444919260373</c:v>
                </c:pt>
                <c:pt idx="1">
                  <c:v>10.90835862592645</c:v>
                </c:pt>
                <c:pt idx="2">
                  <c:v>10.62770261749095</c:v>
                </c:pt>
                <c:pt idx="3">
                  <c:v>10.50074803008305</c:v>
                </c:pt>
                <c:pt idx="4">
                  <c:v>10.70000036780548</c:v>
                </c:pt>
                <c:pt idx="5">
                  <c:v>10.424565619291551</c:v>
                </c:pt>
                <c:pt idx="6">
                  <c:v>11.148459498085719</c:v>
                </c:pt>
                <c:pt idx="7">
                  <c:v>11.56337251928332</c:v>
                </c:pt>
                <c:pt idx="8">
                  <c:v>12.283936030266929</c:v>
                </c:pt>
                <c:pt idx="9">
                  <c:v>11.795521520277219</c:v>
                </c:pt>
                <c:pt idx="10">
                  <c:v>12.414307017025481</c:v>
                </c:pt>
                <c:pt idx="11">
                  <c:v>12.364274292423531</c:v>
                </c:pt>
                <c:pt idx="12">
                  <c:v>13.49184901073775</c:v>
                </c:pt>
                <c:pt idx="13">
                  <c:v>12.934723891145801</c:v>
                </c:pt>
                <c:pt idx="14">
                  <c:v>12.54404047575532</c:v>
                </c:pt>
                <c:pt idx="15">
                  <c:v>11.98298237645545</c:v>
                </c:pt>
                <c:pt idx="16">
                  <c:v>11.94273235988908</c:v>
                </c:pt>
                <c:pt idx="17">
                  <c:v>12.17789819065402</c:v>
                </c:pt>
                <c:pt idx="18">
                  <c:v>12.474667049358381</c:v>
                </c:pt>
                <c:pt idx="19">
                  <c:v>11.9096051522296</c:v>
                </c:pt>
                <c:pt idx="20">
                  <c:v>11.68600700019063</c:v>
                </c:pt>
                <c:pt idx="21">
                  <c:v>11.758289852167049</c:v>
                </c:pt>
                <c:pt idx="22">
                  <c:v>12.188174942742251</c:v>
                </c:pt>
                <c:pt idx="23">
                  <c:v>11.7125649594765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8540160"/>
        <c:axId val="78512128"/>
      </c:lineChart>
      <c:catAx>
        <c:axId val="78540160"/>
        <c:scaling>
          <c:orientation val="minMax"/>
        </c:scaling>
        <c:delete val="1"/>
        <c:axPos val="b"/>
        <c:majorTickMark val="out"/>
        <c:minorTickMark val="none"/>
        <c:tickLblPos val="nextTo"/>
        <c:crossAx val="78512128"/>
        <c:crosses val="autoZero"/>
        <c:auto val="1"/>
        <c:lblAlgn val="ctr"/>
        <c:lblOffset val="100"/>
        <c:noMultiLvlLbl val="0"/>
      </c:catAx>
      <c:valAx>
        <c:axId val="78512128"/>
        <c:scaling>
          <c:orientation val="minMax"/>
          <c:min val="9"/>
        </c:scaling>
        <c:delete val="1"/>
        <c:axPos val="l"/>
        <c:majorGridlines/>
        <c:numFmt formatCode="General" sourceLinked="1"/>
        <c:majorTickMark val="out"/>
        <c:minorTickMark val="none"/>
        <c:tickLblPos val="nextTo"/>
        <c:crossAx val="78540160"/>
        <c:crosses val="autoZero"/>
        <c:crossBetween val="between"/>
        <c:majorUnit val="0.5"/>
        <c:min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979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647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205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291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546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248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640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39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14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550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059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706A4-B5C6-5242-BF62-BB55D992F677}" type="datetimeFigureOut">
              <a:t>9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DAC44-51B1-1248-8755-AC2A35D89E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028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930674" y="712860"/>
            <a:ext cx="4424481" cy="3502248"/>
            <a:chOff x="1319826" y="692474"/>
            <a:chExt cx="4424481" cy="3502248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02701579"/>
                </p:ext>
              </p:extLst>
            </p:nvPr>
          </p:nvGraphicFramePr>
          <p:xfrm>
            <a:off x="1690076" y="741319"/>
            <a:ext cx="4054231" cy="304914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3038044" y="3933112"/>
              <a:ext cx="15960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/>
                  <a:cs typeface="Arial"/>
                </a:rPr>
                <a:t>Hours after inoculation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853782" y="2254048"/>
              <a:ext cx="11936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/>
                  <a:cs typeface="Arial"/>
                </a:rPr>
                <a:t>Log</a:t>
              </a:r>
              <a:r>
                <a:rPr lang="en-US" sz="1100" baseline="-25000">
                  <a:latin typeface="Arial"/>
                  <a:cs typeface="Arial"/>
                </a:rPr>
                <a:t>2</a:t>
              </a:r>
              <a:r>
                <a:rPr lang="en-US" sz="1100">
                  <a:latin typeface="Arial"/>
                  <a:cs typeface="Arial"/>
                </a:rPr>
                <a:t> expression</a:t>
              </a: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1822825" y="3686891"/>
              <a:ext cx="3837669" cy="246221"/>
              <a:chOff x="1803287" y="4389804"/>
              <a:chExt cx="3837669" cy="246221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1803287" y="4389804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2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086148" y="4389804"/>
                <a:ext cx="2559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364863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686800" y="4389804"/>
                <a:ext cx="36293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 14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3018506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18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333612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22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668256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26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994608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30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339021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34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654127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38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008309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42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313648" y="4389804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/>
                    <a:cs typeface="Arial"/>
                  </a:rPr>
                  <a:t>46</a:t>
                </a: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1581436" y="692474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81436" y="1264781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81436" y="1837088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86195" y="2409395"/>
              <a:ext cx="3177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581436" y="2981702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617097" y="3554010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latin typeface="Arial"/>
                  <a:cs typeface="Arial"/>
                </a:rPr>
                <a:t>9</a:t>
              </a:r>
            </a:p>
          </p:txBody>
        </p:sp>
        <p:cxnSp>
          <p:nvCxnSpPr>
            <p:cNvPr id="29" name="Straight Connector 28"/>
            <p:cNvCxnSpPr/>
            <p:nvPr/>
          </p:nvCxnSpPr>
          <p:spPr>
            <a:xfrm flipV="1">
              <a:off x="1881439" y="760857"/>
              <a:ext cx="0" cy="2945572"/>
            </a:xfrm>
            <a:prstGeom prst="line">
              <a:avLst/>
            </a:prstGeom>
            <a:ln w="12700" cmpd="sng">
              <a:solidFill>
                <a:schemeClr val="bg1">
                  <a:lumMod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2" name="Straight Connector 31"/>
          <p:cNvCxnSpPr/>
          <p:nvPr/>
        </p:nvCxnSpPr>
        <p:spPr>
          <a:xfrm>
            <a:off x="3759200" y="3316592"/>
            <a:ext cx="301602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759200" y="3574396"/>
            <a:ext cx="301602" cy="6874"/>
          </a:xfrm>
          <a:prstGeom prst="line">
            <a:avLst/>
          </a:prstGeom>
          <a:ln w="12700" cmpd="sng">
            <a:solidFill>
              <a:schemeClr val="tx1"/>
            </a:solidFill>
            <a:prstDash val="sys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4060802" y="3185787"/>
            <a:ext cx="13530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>
                <a:latin typeface="Arial"/>
                <a:cs typeface="Arial"/>
              </a:rPr>
              <a:t>B. cinerea </a:t>
            </a:r>
            <a:r>
              <a:rPr lang="en-US" sz="1100">
                <a:latin typeface="Arial"/>
                <a:cs typeface="Arial"/>
              </a:rPr>
              <a:t>infected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091595" y="3443591"/>
            <a:ext cx="12040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/>
                <a:cs typeface="Arial"/>
              </a:rPr>
              <a:t>Mock inoculated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092200" y="4817533"/>
            <a:ext cx="49191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cs typeface="Arial"/>
              </a:rPr>
              <a:t>Supplementary </a:t>
            </a:r>
            <a:r>
              <a:rPr lang="en-GB" sz="1200" b="1" smtClean="0">
                <a:cs typeface="Arial"/>
              </a:rPr>
              <a:t>Figure </a:t>
            </a:r>
            <a:r>
              <a:rPr lang="en-GB" sz="1200" b="1" smtClean="0">
                <a:cs typeface="Arial"/>
              </a:rPr>
              <a:t>4. </a:t>
            </a:r>
            <a:r>
              <a:rPr lang="en-GB" sz="1200" b="1" i="1" dirty="0">
                <a:cs typeface="Arial"/>
              </a:rPr>
              <a:t>JAZ6</a:t>
            </a:r>
            <a:r>
              <a:rPr lang="en-GB" sz="1200" b="1" dirty="0">
                <a:cs typeface="Arial"/>
              </a:rPr>
              <a:t> expression is transiently induced during </a:t>
            </a:r>
            <a:r>
              <a:rPr lang="en-GB" sz="1200" b="1" i="1" dirty="0">
                <a:cs typeface="Arial"/>
              </a:rPr>
              <a:t>B. </a:t>
            </a:r>
            <a:r>
              <a:rPr lang="en-GB" sz="1200" b="1" i="1" dirty="0" err="1">
                <a:cs typeface="Arial"/>
              </a:rPr>
              <a:t>cinerea</a:t>
            </a:r>
            <a:r>
              <a:rPr lang="en-GB" sz="1200" b="1" dirty="0">
                <a:cs typeface="Arial"/>
              </a:rPr>
              <a:t> infection</a:t>
            </a:r>
            <a:r>
              <a:rPr lang="en-GB" sz="1200" dirty="0">
                <a:cs typeface="Arial"/>
              </a:rPr>
              <a:t>. The expression of </a:t>
            </a:r>
            <a:r>
              <a:rPr lang="en-GB" sz="1200" i="1" dirty="0">
                <a:cs typeface="Arial"/>
              </a:rPr>
              <a:t>JAZ6</a:t>
            </a:r>
            <a:r>
              <a:rPr lang="en-GB" sz="1200" dirty="0">
                <a:cs typeface="Arial"/>
              </a:rPr>
              <a:t> is shown from the data of </a:t>
            </a:r>
            <a:r>
              <a:rPr lang="en-GB" sz="1200" dirty="0" err="1">
                <a:cs typeface="Arial"/>
              </a:rPr>
              <a:t>Windram</a:t>
            </a:r>
            <a:r>
              <a:rPr lang="en-GB" sz="1200" dirty="0">
                <a:cs typeface="Arial"/>
              </a:rPr>
              <a:t> </a:t>
            </a:r>
            <a:r>
              <a:rPr lang="en-GB" sz="1200" i="1" dirty="0">
                <a:cs typeface="Arial"/>
              </a:rPr>
              <a:t>et al. </a:t>
            </a:r>
            <a:r>
              <a:rPr lang="en-GB" sz="1200" dirty="0">
                <a:cs typeface="Arial"/>
              </a:rPr>
              <a:t>(2012). Arabidopsis leaves were inoculated with </a:t>
            </a:r>
            <a:r>
              <a:rPr lang="en-GB" sz="1200" i="1" dirty="0">
                <a:cs typeface="Arial"/>
              </a:rPr>
              <a:t>B. </a:t>
            </a:r>
            <a:r>
              <a:rPr lang="en-GB" sz="1200" i="1" dirty="0" err="1">
                <a:cs typeface="Arial"/>
              </a:rPr>
              <a:t>cinerea</a:t>
            </a:r>
            <a:r>
              <a:rPr lang="en-GB" sz="1200" dirty="0">
                <a:cs typeface="Arial"/>
              </a:rPr>
              <a:t> spores or mock-inoculated and sampled every 2 hours for 48 hours. The data shown </a:t>
            </a:r>
            <a:r>
              <a:rPr lang="en-GB" sz="1200" dirty="0" smtClean="0">
                <a:cs typeface="Arial"/>
              </a:rPr>
              <a:t>are </a:t>
            </a:r>
            <a:r>
              <a:rPr lang="en-GB" sz="1200" dirty="0">
                <a:cs typeface="Arial"/>
              </a:rPr>
              <a:t>the mean of four biological replicates at each time </a:t>
            </a:r>
            <a:r>
              <a:rPr lang="en-GB" sz="1200" dirty="0" smtClean="0">
                <a:cs typeface="Arial"/>
              </a:rPr>
              <a:t>point ± SEM.</a:t>
            </a:r>
            <a:endParaRPr lang="en-US" sz="120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05754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4</TotalTime>
  <Words>99</Words>
  <Application>Microsoft Office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Warwi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erine Denby</dc:creator>
  <cp:lastModifiedBy>Laura Roden</cp:lastModifiedBy>
  <cp:revision>11</cp:revision>
  <dcterms:created xsi:type="dcterms:W3CDTF">2015-07-14T11:01:11Z</dcterms:created>
  <dcterms:modified xsi:type="dcterms:W3CDTF">2015-09-08T08:14:43Z</dcterms:modified>
</cp:coreProperties>
</file>